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-630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72E1A2A-EF9C-4B03-A845-34376F886E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F4513641-A938-4009-BA93-BB17834BAB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21F0F5F-314B-4521-90F6-083554C78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7EBCBE3-AF34-495A-B321-D1660D9054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31142DB-3698-4A95-986B-784FF0DBB3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477489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75814FD-1199-4BCA-8E38-CE7BBD2EC4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CDC04B06-B56C-478D-AA3E-E54C069FFA6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DA07F33-4977-4830-88A8-2F2DA56B36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B59A7C1-1714-497A-B96E-0D17C2B05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147C339-0B8E-4C2E-B264-008D15DDF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915869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7AD20E49-C3E8-4887-BDD8-48D8D7A8DB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454A453-2406-4CE4-9BB6-4CCB2A6D42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82FD65F-3C6A-4157-AF61-4C48B4BFE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FBE36B1-D7B8-4F78-B914-811034EF56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7AC4FF3-3919-4DB0-8197-AED153E0A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65022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5112206-A21E-40FE-897E-06B777AAA4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30D64E2-A7AA-4757-9643-CC4DA0B517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98F2E22-89C4-4773-A40A-CD395BE45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9EF8559-F8AB-4B61-9277-04C411B6F6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D771B67-A955-4708-98A7-C14EDC0E6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2056504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520DE32-C732-4C89-B0C0-DD20FDFF95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4478AF4-A72C-496C-995A-5E60BF0D4A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E9917D0-547B-4A9A-8C0C-3FEAD30240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5FB4C11-1554-4E95-A1C4-A1F8B0BA1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F66F8DC-4567-4402-AFBD-59C25C2D2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67985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EFF3838-392A-4D33-9077-72FE3CEA97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10688066-3D48-4A4B-A05E-6DA436F2C8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EDCE46C8-1206-4382-A779-F788656408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74FEC41-0468-4919-92F2-27323ED25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10A8223-FBEF-46CA-9ECF-667B966D1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5600212-F95E-4C6E-A910-4C7ACDD9F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731865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546D9B5-47EC-4986-B091-38D177FB71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BC49BC4-12C1-4623-A31A-88B7746FA7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21136FC3-678F-4816-97B8-4960CB966E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B4343DF1-8C19-4D63-85E7-3A3F4EB0CD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83352D4E-04D7-4834-B5D1-D80620E0AB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66597447-DE88-48D8-8B7A-6FC9B112A7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6679721E-2130-40E7-9DCD-7DDA2FF90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04CB98CF-3571-4EAD-9BE3-D57027CC9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777257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993225F-53C0-4835-BF9C-0DC1ED3C87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05B69DDB-EF8F-4BAA-AF1A-A01D74D89D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8A509FA9-044B-4612-85A0-91C4345C7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15DFA6CE-0422-41E1-8C82-30D846D0BC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140251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B97B7BCB-72C3-4D75-B010-C310F543D4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88D2BC8F-39D6-4EE4-BAAB-E19F83A53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268B8B36-91E8-41AC-8181-F2930308B4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852034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FEBC77C-E1DE-472C-ACFC-D932C5ED66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953FF239-C4F0-4A1A-AC8E-1D75F57422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83B4BCB8-1323-4057-BD39-169F6DCF0E9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F75BC62-71E4-4B59-BE9F-91D0F14BE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54E2F84-F318-4F48-9517-E9A2FC8C6A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F839A9C-D0EC-4C6B-9C2C-316D3B7AD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439637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900A08E-93BB-48A1-9AA1-941889031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8E1754FD-5494-4104-A832-CA508E3C4CF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564A2E58-BFB5-4610-BB79-2D0B245273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ADB2E2D-B124-4B6C-B36E-BCD300695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58A93B6-A7A2-4C7C-BB8E-F7ABD7F45F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2CA1487-2E1E-4B6F-9C36-562FD0E5B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76263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014F8BF1-53A3-4A39-A76C-B9C6A9BFF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E2B751C-14CB-4485-96DA-F9285063AC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B864FBD-FA92-49C4-B059-948D34D198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132D85-F272-4816-8706-328CBD6B48C9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F67767D-3E87-4D89-9149-3B47F067E5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2771273-6148-4F52-84FA-F25DFACA5E0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81A162-A371-4F80-B076-C3EB23C229E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412758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FCBE6688-E173-4C43-9432-A6ED503AC0CF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3008067" y="270745"/>
            <a:ext cx="5233641" cy="378798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C13A8BE0-106B-4975-989A-4B16A59532D5}"/>
              </a:ext>
            </a:extLst>
          </p:cNvPr>
          <p:cNvSpPr/>
          <p:nvPr/>
        </p:nvSpPr>
        <p:spPr>
          <a:xfrm>
            <a:off x="2675801" y="3974840"/>
            <a:ext cx="6191361" cy="21698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b="1" dirty="0" smtClean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</a:t>
            </a:r>
            <a:r>
              <a:rPr lang="en-US" b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b="1" smtClean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5</a:t>
            </a:r>
            <a:r>
              <a:rPr lang="en-US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Mean predicted number of </a:t>
            </a:r>
            <a:r>
              <a:rPr lang="en-US" i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. gambiae</a:t>
            </a:r>
            <a:r>
              <a:rPr lang="en-US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.l. collected per night and season over the trapping methods, location and village with 95% CIs. Dry season indicates </a:t>
            </a:r>
            <a:r>
              <a:rPr lang="en-US" i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. gambiae</a:t>
            </a:r>
            <a:r>
              <a:rPr lang="en-US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.l. collected from November to April whilst wet season corresponds to period between May and October.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4399923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5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INE SANOU (student)</dc:creator>
  <cp:lastModifiedBy>0013914</cp:lastModifiedBy>
  <cp:revision>3</cp:revision>
  <dcterms:created xsi:type="dcterms:W3CDTF">2019-03-05T19:49:42Z</dcterms:created>
  <dcterms:modified xsi:type="dcterms:W3CDTF">2019-11-26T07:15:26Z</dcterms:modified>
</cp:coreProperties>
</file>